
<file path=[Content_Types].xml><?xml version="1.0" encoding="utf-8"?>
<Types xmlns="http://schemas.openxmlformats.org/package/2006/content-types"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-1800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6AB1F-083B-40CA-BED9-67E43B3BA0F8}" type="datetimeFigureOut">
              <a:rPr lang="zh-CN" altLang="en-US" smtClean="0"/>
              <a:t>2018/4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AE40F-E6A9-4CAE-ACDA-DA81DCBF3E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22924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6AB1F-083B-40CA-BED9-67E43B3BA0F8}" type="datetimeFigureOut">
              <a:rPr lang="zh-CN" altLang="en-US" smtClean="0"/>
              <a:t>2018/4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AE40F-E6A9-4CAE-ACDA-DA81DCBF3E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83246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6AB1F-083B-40CA-BED9-67E43B3BA0F8}" type="datetimeFigureOut">
              <a:rPr lang="zh-CN" altLang="en-US" smtClean="0"/>
              <a:t>2018/4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AE40F-E6A9-4CAE-ACDA-DA81DCBF3E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777522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6AB1F-083B-40CA-BED9-67E43B3BA0F8}" type="datetimeFigureOut">
              <a:rPr lang="zh-CN" altLang="en-US" smtClean="0"/>
              <a:t>2018/4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AE40F-E6A9-4CAE-ACDA-DA81DCBF3E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24630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6AB1F-083B-40CA-BED9-67E43B3BA0F8}" type="datetimeFigureOut">
              <a:rPr lang="zh-CN" altLang="en-US" smtClean="0"/>
              <a:t>2018/4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AE40F-E6A9-4CAE-ACDA-DA81DCBF3E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85684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6AB1F-083B-40CA-BED9-67E43B3BA0F8}" type="datetimeFigureOut">
              <a:rPr lang="zh-CN" altLang="en-US" smtClean="0"/>
              <a:t>2018/4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AE40F-E6A9-4CAE-ACDA-DA81DCBF3E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43985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6AB1F-083B-40CA-BED9-67E43B3BA0F8}" type="datetimeFigureOut">
              <a:rPr lang="zh-CN" altLang="en-US" smtClean="0"/>
              <a:t>2018/4/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AE40F-E6A9-4CAE-ACDA-DA81DCBF3E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35622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6AB1F-083B-40CA-BED9-67E43B3BA0F8}" type="datetimeFigureOut">
              <a:rPr lang="zh-CN" altLang="en-US" smtClean="0"/>
              <a:t>2018/4/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AE40F-E6A9-4CAE-ACDA-DA81DCBF3E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91724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6AB1F-083B-40CA-BED9-67E43B3BA0F8}" type="datetimeFigureOut">
              <a:rPr lang="zh-CN" altLang="en-US" smtClean="0"/>
              <a:t>2018/4/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AE40F-E6A9-4CAE-ACDA-DA81DCBF3E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61052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6AB1F-083B-40CA-BED9-67E43B3BA0F8}" type="datetimeFigureOut">
              <a:rPr lang="zh-CN" altLang="en-US" smtClean="0"/>
              <a:t>2018/4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AE40F-E6A9-4CAE-ACDA-DA81DCBF3E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70562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6AB1F-083B-40CA-BED9-67E43B3BA0F8}" type="datetimeFigureOut">
              <a:rPr lang="zh-CN" altLang="en-US" smtClean="0"/>
              <a:t>2018/4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AE40F-E6A9-4CAE-ACDA-DA81DCBF3E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52403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96AB1F-083B-40CA-BED9-67E43B3BA0F8}" type="datetimeFigureOut">
              <a:rPr lang="zh-CN" altLang="en-US" smtClean="0"/>
              <a:t>2018/4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7AE40F-E6A9-4CAE-ACDA-DA81DCBF3E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1621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wmf"/><Relationship Id="rId2" Type="http://schemas.openxmlformats.org/officeDocument/2006/relationships/image" Target="../media/image1.w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gif"/><Relationship Id="rId4" Type="http://schemas.openxmlformats.org/officeDocument/2006/relationships/image" Target="../media/image3.g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 descr="fig1a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85850" y="3182938"/>
            <a:ext cx="2087563" cy="1295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195" name="Picture 3" descr="fig1b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83263" y="3073400"/>
            <a:ext cx="2160587" cy="13668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196" name="Rectangle 4"/>
          <p:cNvSpPr txBox="1">
            <a:spLocks noChangeArrowheads="1"/>
          </p:cNvSpPr>
          <p:nvPr/>
        </p:nvSpPr>
        <p:spPr bwMode="auto">
          <a:xfrm>
            <a:off x="3163888" y="1012825"/>
            <a:ext cx="6232525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DE" altLang="zh-CN" b="1" i="1"/>
              <a:t>  </a:t>
            </a:r>
            <a:r>
              <a:rPr lang="de-DE" altLang="zh-CN" sz="2800" b="1" i="1"/>
              <a:t>Visual Ternus</a:t>
            </a:r>
            <a:r>
              <a:rPr lang="de-DE" altLang="zh-CN" sz="2800"/>
              <a:t> </a:t>
            </a:r>
            <a:endParaRPr lang="en-US" altLang="zh-CN" sz="2000"/>
          </a:p>
        </p:txBody>
      </p:sp>
      <p:sp>
        <p:nvSpPr>
          <p:cNvPr id="8197" name="Text Box 5"/>
          <p:cNvSpPr txBox="1">
            <a:spLocks noChangeArrowheads="1"/>
          </p:cNvSpPr>
          <p:nvPr/>
        </p:nvSpPr>
        <p:spPr bwMode="auto">
          <a:xfrm>
            <a:off x="1047750" y="4767263"/>
            <a:ext cx="2719388" cy="30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 typeface="Arial" pitchFamily="34" charset="0"/>
              <a:buNone/>
            </a:pPr>
            <a:r>
              <a:rPr lang="de-DE" altLang="zh-CN" sz="1400"/>
              <a:t>Short ISI- element motion</a:t>
            </a:r>
            <a:endParaRPr lang="en-US" altLang="zh-CN" sz="1400"/>
          </a:p>
        </p:txBody>
      </p:sp>
      <p:sp>
        <p:nvSpPr>
          <p:cNvPr id="8198" name="Text Box 6"/>
          <p:cNvSpPr txBox="1">
            <a:spLocks noChangeArrowheads="1"/>
          </p:cNvSpPr>
          <p:nvPr/>
        </p:nvSpPr>
        <p:spPr bwMode="auto">
          <a:xfrm>
            <a:off x="5999163" y="4767263"/>
            <a:ext cx="2376487" cy="30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 typeface="Arial" pitchFamily="34" charset="0"/>
              <a:buNone/>
            </a:pPr>
            <a:r>
              <a:rPr lang="de-DE" altLang="zh-CN" sz="1400"/>
              <a:t>Long ISI- group motion</a:t>
            </a:r>
            <a:endParaRPr lang="en-US" altLang="zh-CN" sz="1400"/>
          </a:p>
        </p:txBody>
      </p:sp>
      <p:pic>
        <p:nvPicPr>
          <p:cNvPr id="8199" name="Picture 7" descr="TernusAM3"/>
          <p:cNvPicPr>
            <a:picLocks noChangeAspect="1" noChangeArrowheads="1" noCrop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08113" y="2319338"/>
            <a:ext cx="1547812" cy="647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200" name="Picture 6" descr="TernusAM4"/>
          <p:cNvPicPr>
            <a:picLocks noChangeAspect="1" noChangeArrowheads="1" noCrop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43625" y="2319338"/>
            <a:ext cx="1512888" cy="620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1259632" y="5301208"/>
            <a:ext cx="21557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Here the ISI = 0 </a:t>
            </a:r>
            <a:r>
              <a:rPr lang="en-US" altLang="zh-CN" dirty="0" err="1" smtClean="0"/>
              <a:t>ms</a:t>
            </a:r>
            <a:endParaRPr lang="zh-CN" alt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6029532" y="5268942"/>
            <a:ext cx="23461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Here the ISI = 200 </a:t>
            </a:r>
            <a:r>
              <a:rPr lang="en-US" altLang="zh-CN" dirty="0" err="1" smtClean="0"/>
              <a:t>ms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9731808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7</TotalTime>
  <Words>23</Words>
  <Application>Microsoft Office PowerPoint</Application>
  <PresentationFormat>全屏显示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PKU</dc:creator>
  <cp:lastModifiedBy>PKU</cp:lastModifiedBy>
  <cp:revision>2</cp:revision>
  <dcterms:created xsi:type="dcterms:W3CDTF">2018-04-05T06:07:38Z</dcterms:created>
  <dcterms:modified xsi:type="dcterms:W3CDTF">2018-04-05T09:25:17Z</dcterms:modified>
</cp:coreProperties>
</file>